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1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dhuravasal Krishnan, Janani (jananimk)" userId="6969b20d-d298-4095-ade9-5a3c5ff7904a" providerId="ADAL" clId="{CEE075D2-A41C-4527-AD3A-56B4E6ADFBB1}"/>
    <pc:docChg chg="modSld">
      <pc:chgData name="Madhuravasal Krishnan, Janani (jananimk)" userId="6969b20d-d298-4095-ade9-5a3c5ff7904a" providerId="ADAL" clId="{CEE075D2-A41C-4527-AD3A-56B4E6ADFBB1}" dt="2024-07-11T18:38:08.579" v="36" actId="123"/>
      <pc:docMkLst>
        <pc:docMk/>
      </pc:docMkLst>
      <pc:sldChg chg="modSp">
        <pc:chgData name="Madhuravasal Krishnan, Janani (jananimk)" userId="6969b20d-d298-4095-ade9-5a3c5ff7904a" providerId="ADAL" clId="{CEE075D2-A41C-4527-AD3A-56B4E6ADFBB1}" dt="2024-07-11T18:38:08.579" v="36" actId="123"/>
        <pc:sldMkLst>
          <pc:docMk/>
          <pc:sldMk cId="4137421979" sldId="257"/>
        </pc:sldMkLst>
        <pc:spChg chg="mod">
          <ac:chgData name="Madhuravasal Krishnan, Janani (jananimk)" userId="6969b20d-d298-4095-ade9-5a3c5ff7904a" providerId="ADAL" clId="{CEE075D2-A41C-4527-AD3A-56B4E6ADFBB1}" dt="2024-07-11T18:38:08.579" v="36" actId="123"/>
          <ac:spMkLst>
            <pc:docMk/>
            <pc:sldMk cId="4137421979" sldId="257"/>
            <ac:spMk id="7" creationId="{601C5F72-899B-4310-82A4-3408758C4960}"/>
          </ac:spMkLst>
        </pc:spChg>
        <pc:graphicFrameChg chg="mod">
          <ac:chgData name="Madhuravasal Krishnan, Janani (jananimk)" userId="6969b20d-d298-4095-ade9-5a3c5ff7904a" providerId="ADAL" clId="{CEE075D2-A41C-4527-AD3A-56B4E6ADFBB1}" dt="2024-07-11T18:35:43.403" v="32" actId="1036"/>
          <ac:graphicFrameMkLst>
            <pc:docMk/>
            <pc:sldMk cId="4137421979" sldId="257"/>
            <ac:graphicFrameMk id="4" creationId="{67FA9AF8-BE23-491F-B821-B8BFBF32D5CB}"/>
          </ac:graphicFrameMkLst>
        </pc:graphicFrameChg>
        <pc:graphicFrameChg chg="mod">
          <ac:chgData name="Madhuravasal Krishnan, Janani (jananimk)" userId="6969b20d-d298-4095-ade9-5a3c5ff7904a" providerId="ADAL" clId="{CEE075D2-A41C-4527-AD3A-56B4E6ADFBB1}" dt="2024-07-11T18:35:49.688" v="33" actId="1036"/>
          <ac:graphicFrameMkLst>
            <pc:docMk/>
            <pc:sldMk cId="4137421979" sldId="257"/>
            <ac:graphicFrameMk id="5" creationId="{29EFD46D-4627-4134-BA9B-46E66F33A431}"/>
          </ac:graphicFrameMkLst>
        </pc:graphicFrameChg>
      </pc:sldChg>
    </pc:docChg>
  </pc:docChgLst>
  <pc:docChgLst>
    <pc:chgData name="Madhuravasal Krishnan, Janani (jananimk)" userId="6969b20d-d298-4095-ade9-5a3c5ff7904a" providerId="ADAL" clId="{3C5943E4-ACC2-4CBC-AF09-09682438EFA9}"/>
    <pc:docChg chg="addSld delSld modSld">
      <pc:chgData name="Madhuravasal Krishnan, Janani (jananimk)" userId="6969b20d-d298-4095-ade9-5a3c5ff7904a" providerId="ADAL" clId="{3C5943E4-ACC2-4CBC-AF09-09682438EFA9}" dt="2024-06-12T20:11:05.635" v="22" actId="20577"/>
      <pc:docMkLst>
        <pc:docMk/>
      </pc:docMkLst>
      <pc:sldChg chg="modSp add">
        <pc:chgData name="Madhuravasal Krishnan, Janani (jananimk)" userId="6969b20d-d298-4095-ade9-5a3c5ff7904a" providerId="ADAL" clId="{3C5943E4-ACC2-4CBC-AF09-09682438EFA9}" dt="2024-06-12T20:11:05.635" v="22" actId="20577"/>
        <pc:sldMkLst>
          <pc:docMk/>
          <pc:sldMk cId="4137421979" sldId="257"/>
        </pc:sldMkLst>
        <pc:spChg chg="mod">
          <ac:chgData name="Madhuravasal Krishnan, Janani (jananimk)" userId="6969b20d-d298-4095-ade9-5a3c5ff7904a" providerId="ADAL" clId="{3C5943E4-ACC2-4CBC-AF09-09682438EFA9}" dt="2024-06-12T20:11:05.635" v="22" actId="20577"/>
          <ac:spMkLst>
            <pc:docMk/>
            <pc:sldMk cId="4137421979" sldId="257"/>
            <ac:spMk id="7" creationId="{601C5F72-899B-4310-82A4-3408758C4960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mailuc-my.sharepoint.com/personal/jananimk_ucmail_uc_edu/Documents/202/2023/T%20cell%20isolation/March%20controls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mailuc-my.sharepoint.com/personal/jananimk_ucmail_uc_edu/Documents/202/ELISA%20for%20Tcell%20infections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521867612063069"/>
          <c:y val="7.3878196074239774E-2"/>
          <c:w val="0.71529991677869531"/>
          <c:h val="0.4915912995014544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ontrol 63'!$I$39:$L$39</c:f>
                <c:numCache>
                  <c:formatCode>General</c:formatCode>
                  <c:ptCount val="4"/>
                  <c:pt idx="0">
                    <c:v>0.18581162261399378</c:v>
                  </c:pt>
                  <c:pt idx="1">
                    <c:v>9.2012486198276885E-2</c:v>
                  </c:pt>
                  <c:pt idx="2">
                    <c:v>0.14873863060206766</c:v>
                  </c:pt>
                  <c:pt idx="3">
                    <c:v>0.48485220275839547</c:v>
                  </c:pt>
                </c:numCache>
              </c:numRef>
            </c:plus>
            <c:minus>
              <c:numRef>
                <c:f>'Control 63'!$I$39:$L$39</c:f>
                <c:numCache>
                  <c:formatCode>General</c:formatCode>
                  <c:ptCount val="4"/>
                  <c:pt idx="0">
                    <c:v>0.18581162261399378</c:v>
                  </c:pt>
                  <c:pt idx="1">
                    <c:v>9.2012486198276885E-2</c:v>
                  </c:pt>
                  <c:pt idx="2">
                    <c:v>0.14873863060206766</c:v>
                  </c:pt>
                  <c:pt idx="3">
                    <c:v>0.484852202758395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ontrol 63'!$I$37:$L$37</c:f>
              <c:strCache>
                <c:ptCount val="4"/>
                <c:pt idx="0">
                  <c:v>No HIV/ no drug</c:v>
                </c:pt>
                <c:pt idx="1">
                  <c:v>HIV/no drug</c:v>
                </c:pt>
                <c:pt idx="2">
                  <c:v>HIV+10ug fentanyl</c:v>
                </c:pt>
                <c:pt idx="3">
                  <c:v>HIV+10ug fentanyl+10ug naltrexone</c:v>
                </c:pt>
              </c:strCache>
            </c:strRef>
          </c:cat>
          <c:val>
            <c:numRef>
              <c:f>'Control 63'!$I$38:$L$38</c:f>
              <c:numCache>
                <c:formatCode>General</c:formatCode>
                <c:ptCount val="4"/>
                <c:pt idx="0">
                  <c:v>-0.50991427609336126</c:v>
                </c:pt>
                <c:pt idx="1">
                  <c:v>2.9785177713507718</c:v>
                </c:pt>
                <c:pt idx="2">
                  <c:v>4.7573180693322445</c:v>
                </c:pt>
                <c:pt idx="3">
                  <c:v>3.20323659450663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01-45FF-98EA-4A402B4EB7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48654064"/>
        <c:axId val="1548653232"/>
      </c:barChart>
      <c:catAx>
        <c:axId val="15486540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15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48653232"/>
        <c:crosses val="autoZero"/>
        <c:auto val="1"/>
        <c:lblAlgn val="ctr"/>
        <c:lblOffset val="100"/>
        <c:noMultiLvlLbl val="0"/>
      </c:catAx>
      <c:valAx>
        <c:axId val="15486532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48654064"/>
        <c:crosses val="autoZero"/>
        <c:crossBetween val="between"/>
        <c:majorUnit val="1"/>
        <c:min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70253718285214"/>
          <c:y val="5.6632040994351991E-2"/>
          <c:w val="0.76982648002333043"/>
          <c:h val="0.4776215158155908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63'!$G$5:$G$8</c:f>
                <c:numCache>
                  <c:formatCode>General</c:formatCode>
                  <c:ptCount val="4"/>
                  <c:pt idx="0">
                    <c:v>2.0496371026112268</c:v>
                  </c:pt>
                  <c:pt idx="1">
                    <c:v>2.2359677483031515</c:v>
                  </c:pt>
                  <c:pt idx="2">
                    <c:v>4.0992742052224385</c:v>
                  </c:pt>
                  <c:pt idx="3">
                    <c:v>4.2856048509143809</c:v>
                  </c:pt>
                </c:numCache>
              </c:numRef>
            </c:plus>
            <c:minus>
              <c:numRef>
                <c:f>'63'!$G$5:$G$8</c:f>
                <c:numCache>
                  <c:formatCode>General</c:formatCode>
                  <c:ptCount val="4"/>
                  <c:pt idx="0">
                    <c:v>2.0496371026112268</c:v>
                  </c:pt>
                  <c:pt idx="1">
                    <c:v>2.2359677483031515</c:v>
                  </c:pt>
                  <c:pt idx="2">
                    <c:v>4.0992742052224385</c:v>
                  </c:pt>
                  <c:pt idx="3">
                    <c:v>4.28560485091438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63'!$A$5:$A$8</c:f>
              <c:strCache>
                <c:ptCount val="4"/>
                <c:pt idx="0">
                  <c:v>No HIV/ no drug</c:v>
                </c:pt>
                <c:pt idx="1">
                  <c:v>HIV/no drug</c:v>
                </c:pt>
                <c:pt idx="2">
                  <c:v>HIV+10ug fentanyl</c:v>
                </c:pt>
                <c:pt idx="3">
                  <c:v>HIV+10ug fentanyl+10ug naltrexone</c:v>
                </c:pt>
              </c:strCache>
            </c:strRef>
          </c:cat>
          <c:val>
            <c:numRef>
              <c:f>'63'!$F$5:$F$8</c:f>
              <c:numCache>
                <c:formatCode>General</c:formatCode>
                <c:ptCount val="4"/>
                <c:pt idx="0">
                  <c:v>8.5333184930312154</c:v>
                </c:pt>
                <c:pt idx="1">
                  <c:v>48.191773089632264</c:v>
                </c:pt>
                <c:pt idx="2">
                  <c:v>75.860462343074857</c:v>
                </c:pt>
                <c:pt idx="3">
                  <c:v>45.424904164288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039-4C78-AC8C-F001C628C3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1243983"/>
        <c:axId val="1884350575"/>
      </c:barChart>
      <c:catAx>
        <c:axId val="14124398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15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84350575"/>
        <c:crosses val="autoZero"/>
        <c:auto val="1"/>
        <c:lblAlgn val="ctr"/>
        <c:lblOffset val="100"/>
        <c:noMultiLvlLbl val="0"/>
      </c:catAx>
      <c:valAx>
        <c:axId val="188435057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41243983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7851</cdr:x>
      <cdr:y>0</cdr:y>
    </cdr:from>
    <cdr:to>
      <cdr:x>0.16667</cdr:x>
      <cdr:y>0.64194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7A2B07ED-FEB2-0D3D-168F-4DB68F46D945}"/>
            </a:ext>
          </a:extLst>
        </cdr:cNvPr>
        <cdr:cNvSpPr txBox="1"/>
      </cdr:nvSpPr>
      <cdr:spPr>
        <a:xfrm xmlns:a="http://schemas.openxmlformats.org/drawingml/2006/main" rot="16200000">
          <a:off x="-398466" y="851615"/>
          <a:ext cx="2212109" cy="50887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DNA proviral load</a:t>
          </a:r>
        </a:p>
        <a:p xmlns:a="http://schemas.openxmlformats.org/drawingml/2006/main">
          <a:pPr algn="ctr"/>
          <a:r>
            <a:rPr lang="en-US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(log copies / 1 × 10</a:t>
          </a:r>
          <a:r>
            <a:rPr 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rPr>
            <a:t>5</a:t>
          </a:r>
          <a:r>
            <a:rPr lang="en-US" sz="1200" baseline="0" dirty="0">
              <a:latin typeface="Times New Roman" panose="02020603050405020304" pitchFamily="18" charset="0"/>
              <a:cs typeface="Times New Roman" panose="02020603050405020304" pitchFamily="18" charset="0"/>
            </a:rPr>
            <a:t>cells</a:t>
          </a:r>
          <a:r>
            <a:rPr lang="en-US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)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934</cdr:x>
      <cdr:y>0.04286</cdr:y>
    </cdr:from>
    <cdr:to>
      <cdr:x>0.14548</cdr:x>
      <cdr:y>0.5584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E865C1D8-282D-4780-8A65-FCD40EC6FDA9}"/>
            </a:ext>
          </a:extLst>
        </cdr:cNvPr>
        <cdr:cNvSpPr txBox="1"/>
      </cdr:nvSpPr>
      <cdr:spPr>
        <a:xfrm xmlns:a="http://schemas.openxmlformats.org/drawingml/2006/main" rot="16200000">
          <a:off x="-203968" y="828760"/>
          <a:ext cx="1654193" cy="27170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sz="1200" b="0" i="0" baseline="0" dirty="0"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HIV p24 (</a:t>
          </a:r>
          <a:r>
            <a:rPr lang="en-US" sz="1200" b="0" i="0" baseline="0" dirty="0" err="1"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pg</a:t>
          </a:r>
          <a:r>
            <a:rPr lang="en-US" sz="1200" b="0" i="0" baseline="0" dirty="0"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/mL)</a:t>
          </a:r>
          <a:endParaRPr lang="en-US" sz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F6F3FF-1634-46FB-8558-737B898BC6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D825C01-A93B-4CD1-AE70-82C42D00D3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270AA8-A85A-437D-8188-E48AC2ACDC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B6C247-B2D2-4A71-BB34-98EF8233E2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6F0C05-0436-4714-9618-25DBC69F93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86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42C39B-88E5-44F9-9A05-AC8FBFCCBF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7F1026-FA44-4CCE-8A75-F10261EE9B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8CED01-D738-480C-AAEA-B2ED483D3D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9977B5-D753-4EBC-9B25-D7F40DFB19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7D8CB3-98D3-4FD3-A63A-8D3054825C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9575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65F8BEB-9B20-4045-B34F-95D47E0301D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D90A32D-5C8D-4DC0-B16B-4004DF98A6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CE0659-E408-435E-B14A-2F6F77214E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1179E1-3023-4434-A924-4D0EB5114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C0238F-E676-406A-A3E6-1C0228C384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756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7601E3-BC5E-4752-BFFD-B5C158A271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2D9ED6-901D-465F-AF59-7E44D605FC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35D457-BE82-4080-9BCD-7B363FB83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9A7A79-EE5D-42F5-BE9C-B32CF15A04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299EB8-954C-40FE-AC10-3838CDAFE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6066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43D5D4-E889-4071-A5C7-EBC5240694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6AB7E13-F656-40E0-ADAC-ADFA4600B4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20CE46-9E74-4040-B53B-B02C55754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0FD2C1-128A-4177-AF5D-C389AD2830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720634-7D4B-410B-AB13-3E65547452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63214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FB5FBD-6845-4995-B1D7-F52C6A8A7F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5B1102-8386-4594-8657-90F33FFB56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819FBF-7A28-4083-9DC7-620CDC89A5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E45F86-73FA-4027-8235-5069418B1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6E3473-B44C-4D33-890C-D40122D1B8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619EB2-BA40-45B4-95F9-5B1DD220A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3531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03AE75-36D8-4CD4-9212-5DCF26A843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D9669F-5026-4B6B-95E5-676A75819D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F296D16-1C5E-46F5-A081-8EC9D9C6CE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FF50208-01C0-499F-B10B-F9A00A74B5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EEC26BA-9AC0-4037-9A4C-87A5FFD80D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6ADDF87-4535-4362-91BC-7C98D5AD97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35000C3-1731-4FD0-B988-E64F64AC55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B8ADEFC-2B26-4B71-BF6D-1908484C3D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046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D570DC-DCC4-4F2D-B3B3-874CC70A01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325611C-CCDB-4CCF-B690-B5A5D88A3C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AA96AE4-D1D3-4C9A-A996-93774C71A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5F5FF0A-119C-4274-9F2F-196BD22158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695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47352CA-F186-45D2-A2D7-8492E234DB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9589844-B7FB-4C6B-A3C2-47AA3CB90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AB2F01-F224-4D0B-982C-3FAAFF1165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892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F116FA-C32D-4FE1-9E00-B7D02F5AF8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81279C-A06F-4395-A1FB-33DC648704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80246E-B5CC-4B1F-8EC2-F0903F5279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F66587-B95F-4DBC-A7F8-71C18FA626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830BC7-D80B-4143-832A-5AC3FF272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CDB746-EDE8-42ED-B2C6-1752C43DA5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861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34C7EB-0115-4042-8547-628FDA9873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A2D116C-C3DD-4FB5-9780-97F79279D0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F07258-4668-4638-8918-2DEE600321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E650AD-A7F1-4E34-8525-62C5AE4379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B7CC5-B96B-466D-AA3E-D687737FC8E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F51537-50AC-4DB9-9CD6-01749BFC24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48F35F-3970-4796-9F48-CE31788328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4605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594A903-5624-45CF-83B6-D47E5D0BAC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B021FA-9E01-41E2-90B0-FBEF5732D6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A989C0-60A4-46A7-99F8-E31CAEFF5E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3B7CC5-B96B-466D-AA3E-D687737FC8E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76B337-889F-4A8D-B21D-4FE8D35A6CC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996F00-1FDD-458F-8191-EEC0872B8A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6A5039-8F74-4E68-9DA5-F3CB28F5DE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699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67FA9AF8-BE23-491F-B821-B8BFBF32D5C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78765660"/>
              </p:ext>
            </p:extLst>
          </p:nvPr>
        </p:nvGraphicFramePr>
        <p:xfrm>
          <a:off x="48520" y="1383033"/>
          <a:ext cx="6317864" cy="41381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65F75F82-6AE6-F11C-C851-E8B26C248892}"/>
              </a:ext>
            </a:extLst>
          </p:cNvPr>
          <p:cNvSpPr txBox="1"/>
          <p:nvPr/>
        </p:nvSpPr>
        <p:spPr>
          <a:xfrm>
            <a:off x="10498348" y="114515"/>
            <a:ext cx="12594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ID : 63</a:t>
            </a: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29EFD46D-4627-4134-BA9B-46E66F33A43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9269129"/>
              </p:ext>
            </p:extLst>
          </p:nvPr>
        </p:nvGraphicFramePr>
        <p:xfrm>
          <a:off x="5941822" y="1604516"/>
          <a:ext cx="5217074" cy="34267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601C5F72-899B-4310-82A4-3408758C4960}"/>
              </a:ext>
            </a:extLst>
          </p:cNvPr>
          <p:cNvSpPr txBox="1"/>
          <p:nvPr/>
        </p:nvSpPr>
        <p:spPr>
          <a:xfrm>
            <a:off x="0" y="5842337"/>
            <a:ext cx="1219200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2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: PBMC derived </a:t>
            </a:r>
            <a:r>
              <a:rPr lang="en-US" sz="1200" dirty="0">
                <a:latin typeface="Times New Roman" panose="02020603050405020304" pitchFamily="18" charset="0"/>
              </a:rPr>
              <a:t>CD4</a:t>
            </a:r>
            <a:r>
              <a:rPr lang="en-US" sz="1200" baseline="30000" dirty="0">
                <a:latin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T cells were seeded at ~1 × 10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5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ells per well. 10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 of naltrexone was added into the respective well and the cells are incubated for 24 hrs. After incubation cells were infected with HIV</a:t>
            </a:r>
            <a:r>
              <a:rPr lang="en-US" sz="105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L4-3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 at MOI of 1 for 2 hours and rinsed with RPMI + 10% FBS + 1% antibiotics (Pen/Strep) + 1% glutamine for three times to remove any unbound virus and replaced with fresh media. Fentanyl at concentration of 10ug/mL was added to the respective well and incubated. After incubation with drug and virus for 72 hours, HIV proviral DNA was quantified in cells by real-time PCR based on SYBR Green I detection and HIV p24 antigen expression was estimated from the cell culture supernatant. Error bar represents the standard deviations between the replicate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74219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77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SimSun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dhuravasal Krishnan, Janani (jananimk)</dc:creator>
  <cp:lastModifiedBy>Madhuravasal Krishnan, Janani (jananimk)</cp:lastModifiedBy>
  <cp:revision>1</cp:revision>
  <dcterms:created xsi:type="dcterms:W3CDTF">2024-06-12T20:05:21Z</dcterms:created>
  <dcterms:modified xsi:type="dcterms:W3CDTF">2024-07-11T18:38:09Z</dcterms:modified>
</cp:coreProperties>
</file>